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325" r:id="rId3"/>
    <p:sldId id="326" r:id="rId4"/>
    <p:sldId id="31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7D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9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57BB334-7460-4F59-B4DD-F392D99BA5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BD81AC74-5754-4C31-9AEF-D9B11FC41E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661F4C5-E455-4D70-843B-0125388B1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DC898FE-FB76-433F-B333-3B76453E43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564225C-7E87-4E08-B1D2-A7DF248B6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217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A364321-424F-4C18-A436-A336F8359D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F4429D52-C54E-43DC-9519-132F060C07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AB97B73-0C96-4D76-9A09-78378BC5F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34852E1-2408-431F-9C82-F47434014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BA6C854-09D2-493E-B212-E054856716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2932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0C2CCAE1-66AE-445D-B300-F8E61E0BC9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225C251A-6327-49B8-AB6B-ACB607126D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5E2FCA5-FC62-4406-A7CF-7014AF9D6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C3062E7-D67A-4569-83C3-DE9F8A200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6D645C2-13A1-49A9-8BDE-9BC9F9B844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622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1EACA81-6064-4079-BD66-BDCA85E335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A99F8AD-BE7F-4686-B633-ACC18BF2C8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3DE8293-9C8A-4AF7-943B-F8E958EF1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C4BA7D9-328A-4473-A81A-4A5B43FEED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5DF278A-181D-41A9-8830-CE789AD0C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981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DCF9A3A-77D2-40B7-975C-CBF0DC9F68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0BA1921-641F-4F50-BF50-6FFBBA83CE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2BA1682-EA32-4599-8657-0D3B05CBE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F3A1911-90BB-4103-AA81-B2223A993A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953A849-1151-48B6-BC9B-3FAA6D491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25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CA2BE2C-109C-4F4C-8BD4-6C0EB917A8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4B4B445-95BB-4655-A21F-0ED3E44816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6C3F3AE1-5EE2-4657-8B47-A2BFB60189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99FF6FF-FC70-4F34-AE89-27B24442A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0AE746E-4D91-4519-A2A1-F273E689C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D43740C8-9B59-4E2A-97FB-982CA6E477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20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B389E52-4D3A-4DC4-8E7F-25B5419101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7DEEFE6-2AC6-47BC-8C70-2D693BCD78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36255308-C5CF-407B-8A1B-EC1E7DA874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107C8141-E244-4B09-9109-728AEFE1BA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D27F33A5-8885-4FB3-8BC3-C6300EB05E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F14C8C28-CF1C-425B-9F99-34F8E3EA7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35C377D7-A329-4E2E-ADC3-BD60FA130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95509727-8D8B-43A3-994D-7890C0BF4E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854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484F0C6-828F-48DB-B393-AA84A68787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E121A136-9D57-4A89-A18F-93CA5B2BB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85B952A1-A036-4E90-B548-41F319E43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D06AF421-0D3A-453A-B007-EFCFFDA01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773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B5D6BE23-ED51-4471-A42D-AF7B8EBAD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5888C946-51C9-4B09-9F38-E23428A57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EB386DAC-D148-4CEC-B766-EF0DB0013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711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03C1DC1-4B17-45EF-8B5C-4B34E2CEB1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C12F3D8-102E-4726-B07B-8F7CEE959E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01BD743-AFCF-40AE-830C-0643E5129B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D62B349-09B0-424E-A9DD-1BE9F6775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ED44671-3DD4-4925-B103-B42243AE1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0D3429F-5762-4793-9F90-11DF05ACC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819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7095274-7B18-4B4F-82E2-1C6F46109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FE63CEC1-5014-4E3C-B1FC-2B2A5A4689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91C1CF2-537C-4B43-ADDA-3E96DAF251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B25E647-93F9-4AB4-B7D5-E2ADCA3D4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404FBA8-8F56-470B-8DFA-71A60CC4B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35EEC81-40A3-4556-A40B-10ED83B8E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039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53A42A99-234D-455C-A390-EBABA459B9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51BC939-0871-4490-9EE6-4C33C1DEEA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D0BA815-B60C-4525-9742-79DCE3A627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9068F9-A6DA-4E73-9758-9D10189EF014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BA57EE4-AFA0-4BE2-B4AC-1179485B43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8147611-98AB-4193-8CB8-AD9EB829B2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444B6F-1167-4BF0-B736-633ABCA8D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994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151E8524-CCE7-438F-BDDC-2123570485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7047266"/>
              </p:ext>
            </p:extLst>
          </p:nvPr>
        </p:nvGraphicFramePr>
        <p:xfrm>
          <a:off x="2313267" y="2097686"/>
          <a:ext cx="6351095" cy="2476500"/>
        </p:xfrm>
        <a:graphic>
          <a:graphicData uri="http://schemas.openxmlformats.org/drawingml/2006/table">
            <a:tbl>
              <a:tblPr/>
              <a:tblGrid>
                <a:gridCol w="1524000">
                  <a:extLst>
                    <a:ext uri="{9D8B030D-6E8A-4147-A177-3AD203B41FA5}">
                      <a16:colId xmlns:a16="http://schemas.microsoft.com/office/drawing/2014/main" xmlns="" val="3931722029"/>
                    </a:ext>
                  </a:extLst>
                </a:gridCol>
                <a:gridCol w="1536700">
                  <a:extLst>
                    <a:ext uri="{9D8B030D-6E8A-4147-A177-3AD203B41FA5}">
                      <a16:colId xmlns:a16="http://schemas.microsoft.com/office/drawing/2014/main" xmlns="" val="2368572298"/>
                    </a:ext>
                  </a:extLst>
                </a:gridCol>
                <a:gridCol w="1503540">
                  <a:extLst>
                    <a:ext uri="{9D8B030D-6E8A-4147-A177-3AD203B41FA5}">
                      <a16:colId xmlns:a16="http://schemas.microsoft.com/office/drawing/2014/main" xmlns="" val="282322929"/>
                    </a:ext>
                  </a:extLst>
                </a:gridCol>
                <a:gridCol w="553674">
                  <a:extLst>
                    <a:ext uri="{9D8B030D-6E8A-4147-A177-3AD203B41FA5}">
                      <a16:colId xmlns:a16="http://schemas.microsoft.com/office/drawing/2014/main" xmlns="" val="468337552"/>
                    </a:ext>
                  </a:extLst>
                </a:gridCol>
                <a:gridCol w="570451">
                  <a:extLst>
                    <a:ext uri="{9D8B030D-6E8A-4147-A177-3AD203B41FA5}">
                      <a16:colId xmlns:a16="http://schemas.microsoft.com/office/drawing/2014/main" xmlns="" val="823067908"/>
                    </a:ext>
                  </a:extLst>
                </a:gridCol>
                <a:gridCol w="662730">
                  <a:extLst>
                    <a:ext uri="{9D8B030D-6E8A-4147-A177-3AD203B41FA5}">
                      <a16:colId xmlns:a16="http://schemas.microsoft.com/office/drawing/2014/main" xmlns="" val="4012818872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racteristi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w PAQR7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gh PAQR7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isti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o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1749024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6304113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isq.te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0499247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 (19.1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 (19.3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2951846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1 (30.7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 (28.7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4755447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0.6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 (1.6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9435266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isq.te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2619082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9 (39.7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8 (41.8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0033799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 (10.3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 (8.2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1682315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sher.te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479118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6 (49.3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9 (50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309723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0.7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6644451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, median (IQR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 (57, 66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 (56, 66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546.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lcoxo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00271754"/>
                  </a:ext>
                </a:extLst>
              </a:tr>
            </a:tbl>
          </a:graphicData>
        </a:graphic>
      </p:graphicFrame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xmlns="" id="{2F194FA7-1B98-4BC2-A272-625E769868CA}"/>
              </a:ext>
            </a:extLst>
          </p:cNvPr>
          <p:cNvCxnSpPr/>
          <p:nvPr/>
        </p:nvCxnSpPr>
        <p:spPr>
          <a:xfrm>
            <a:off x="2732367" y="2320207"/>
            <a:ext cx="6019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xmlns="" id="{BA5F4EA0-4A5F-4B3C-9555-D2BB28413A2B}"/>
              </a:ext>
            </a:extLst>
          </p:cNvPr>
          <p:cNvCxnSpPr/>
          <p:nvPr/>
        </p:nvCxnSpPr>
        <p:spPr>
          <a:xfrm>
            <a:off x="2732367" y="2097686"/>
            <a:ext cx="6019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xmlns="" id="{224945E5-8EBA-442D-9172-033D99E76F69}"/>
              </a:ext>
            </a:extLst>
          </p:cNvPr>
          <p:cNvCxnSpPr/>
          <p:nvPr/>
        </p:nvCxnSpPr>
        <p:spPr>
          <a:xfrm>
            <a:off x="2649875" y="4574186"/>
            <a:ext cx="6019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C998EC88-5515-4E51-B8B5-10EF4CB8FAB8}"/>
              </a:ext>
            </a:extLst>
          </p:cNvPr>
          <p:cNvSpPr txBox="1"/>
          <p:nvPr/>
        </p:nvSpPr>
        <p:spPr>
          <a:xfrm>
            <a:off x="3908014" y="1789908"/>
            <a:ext cx="3176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able S1. PAQR7 expression in prostate cancers</a:t>
            </a:r>
          </a:p>
        </p:txBody>
      </p:sp>
    </p:spTree>
    <p:extLst>
      <p:ext uri="{BB962C8B-B14F-4D97-AF65-F5344CB8AC3E}">
        <p14:creationId xmlns:p14="http://schemas.microsoft.com/office/powerpoint/2010/main" val="27948950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308A0342-0418-4E1F-9A7D-4AFA9324B7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7818049"/>
              </p:ext>
            </p:extLst>
          </p:nvPr>
        </p:nvGraphicFramePr>
        <p:xfrm>
          <a:off x="2582239" y="1830808"/>
          <a:ext cx="6018925" cy="2476500"/>
        </p:xfrm>
        <a:graphic>
          <a:graphicData uri="http://schemas.openxmlformats.org/drawingml/2006/table">
            <a:tbl>
              <a:tblPr/>
              <a:tblGrid>
                <a:gridCol w="1157550">
                  <a:extLst>
                    <a:ext uri="{9D8B030D-6E8A-4147-A177-3AD203B41FA5}">
                      <a16:colId xmlns:a16="http://schemas.microsoft.com/office/drawing/2014/main" xmlns="" val="722449448"/>
                    </a:ext>
                  </a:extLst>
                </a:gridCol>
                <a:gridCol w="1522557">
                  <a:extLst>
                    <a:ext uri="{9D8B030D-6E8A-4147-A177-3AD203B41FA5}">
                      <a16:colId xmlns:a16="http://schemas.microsoft.com/office/drawing/2014/main" xmlns="" val="493876612"/>
                    </a:ext>
                  </a:extLst>
                </a:gridCol>
                <a:gridCol w="1526796">
                  <a:extLst>
                    <a:ext uri="{9D8B030D-6E8A-4147-A177-3AD203B41FA5}">
                      <a16:colId xmlns:a16="http://schemas.microsoft.com/office/drawing/2014/main" xmlns="" val="964411194"/>
                    </a:ext>
                  </a:extLst>
                </a:gridCol>
                <a:gridCol w="562063">
                  <a:extLst>
                    <a:ext uri="{9D8B030D-6E8A-4147-A177-3AD203B41FA5}">
                      <a16:colId xmlns:a16="http://schemas.microsoft.com/office/drawing/2014/main" xmlns="" val="620077801"/>
                    </a:ext>
                  </a:extLst>
                </a:gridCol>
                <a:gridCol w="595618">
                  <a:extLst>
                    <a:ext uri="{9D8B030D-6E8A-4147-A177-3AD203B41FA5}">
                      <a16:colId xmlns:a16="http://schemas.microsoft.com/office/drawing/2014/main" xmlns="" val="3942832392"/>
                    </a:ext>
                  </a:extLst>
                </a:gridCol>
                <a:gridCol w="654341">
                  <a:extLst>
                    <a:ext uri="{9D8B030D-6E8A-4147-A177-3AD203B41FA5}">
                      <a16:colId xmlns:a16="http://schemas.microsoft.com/office/drawing/2014/main" xmlns="" val="1378074666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racteristi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w PAQR8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gh PAQR8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isti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o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5010730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242817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isq.te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4231443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 (20.3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 (18.1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8077917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 (29.3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8 (30.1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1840004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0.6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 (1.6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1409075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isq.te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1798969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0 (39.9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7 (41.5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7856493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 (9.2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 (9.4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5421106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sher.te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3183974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8 (49.8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7 (49.6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9866105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0.2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0.4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1753492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, median (IQR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 (56, 66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 (56, 66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816.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lcoxo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08353887"/>
                  </a:ext>
                </a:extLst>
              </a:tr>
            </a:tbl>
          </a:graphicData>
        </a:graphic>
      </p:graphicFrame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xmlns="" id="{624E2D73-82D9-4323-B593-07224BF5EAAD}"/>
              </a:ext>
            </a:extLst>
          </p:cNvPr>
          <p:cNvCxnSpPr/>
          <p:nvPr/>
        </p:nvCxnSpPr>
        <p:spPr>
          <a:xfrm>
            <a:off x="2582239" y="4325082"/>
            <a:ext cx="6019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xmlns="" id="{08E9AB85-04A3-4F00-907D-9C1A70BD8FFD}"/>
              </a:ext>
            </a:extLst>
          </p:cNvPr>
          <p:cNvCxnSpPr/>
          <p:nvPr/>
        </p:nvCxnSpPr>
        <p:spPr>
          <a:xfrm>
            <a:off x="2595504" y="2019507"/>
            <a:ext cx="6019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xmlns="" id="{5377DC59-AFEF-4B99-9969-0BD792784C96}"/>
              </a:ext>
            </a:extLst>
          </p:cNvPr>
          <p:cNvCxnSpPr/>
          <p:nvPr/>
        </p:nvCxnSpPr>
        <p:spPr>
          <a:xfrm>
            <a:off x="2581364" y="1830808"/>
            <a:ext cx="6019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FC878273-05D1-4F5E-8BBF-7E403439E9A8}"/>
              </a:ext>
            </a:extLst>
          </p:cNvPr>
          <p:cNvSpPr txBox="1"/>
          <p:nvPr/>
        </p:nvSpPr>
        <p:spPr>
          <a:xfrm>
            <a:off x="4003040" y="1553917"/>
            <a:ext cx="3176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able S2. PAQR8 expression in prostate cancers</a:t>
            </a:r>
          </a:p>
        </p:txBody>
      </p:sp>
    </p:spTree>
    <p:extLst>
      <p:ext uri="{BB962C8B-B14F-4D97-AF65-F5344CB8AC3E}">
        <p14:creationId xmlns:p14="http://schemas.microsoft.com/office/powerpoint/2010/main" val="31273187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4CAFDB01-7175-462C-A56E-3E87A8C3AE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8557475"/>
              </p:ext>
            </p:extLst>
          </p:nvPr>
        </p:nvGraphicFramePr>
        <p:xfrm>
          <a:off x="2989713" y="2190750"/>
          <a:ext cx="5513033" cy="2476500"/>
        </p:xfrm>
        <a:graphic>
          <a:graphicData uri="http://schemas.openxmlformats.org/drawingml/2006/table">
            <a:tbl>
              <a:tblPr/>
              <a:tblGrid>
                <a:gridCol w="1065321">
                  <a:extLst>
                    <a:ext uri="{9D8B030D-6E8A-4147-A177-3AD203B41FA5}">
                      <a16:colId xmlns:a16="http://schemas.microsoft.com/office/drawing/2014/main" xmlns="" val="3927187359"/>
                    </a:ext>
                  </a:extLst>
                </a:gridCol>
                <a:gridCol w="1216240">
                  <a:extLst>
                    <a:ext uri="{9D8B030D-6E8A-4147-A177-3AD203B41FA5}">
                      <a16:colId xmlns:a16="http://schemas.microsoft.com/office/drawing/2014/main" xmlns="" val="413694218"/>
                    </a:ext>
                  </a:extLst>
                </a:gridCol>
                <a:gridCol w="1003177">
                  <a:extLst>
                    <a:ext uri="{9D8B030D-6E8A-4147-A177-3AD203B41FA5}">
                      <a16:colId xmlns:a16="http://schemas.microsoft.com/office/drawing/2014/main" xmlns="" val="3565881600"/>
                    </a:ext>
                  </a:extLst>
                </a:gridCol>
                <a:gridCol w="790113">
                  <a:extLst>
                    <a:ext uri="{9D8B030D-6E8A-4147-A177-3AD203B41FA5}">
                      <a16:colId xmlns:a16="http://schemas.microsoft.com/office/drawing/2014/main" xmlns="" val="4187483170"/>
                    </a:ext>
                  </a:extLst>
                </a:gridCol>
                <a:gridCol w="727969">
                  <a:extLst>
                    <a:ext uri="{9D8B030D-6E8A-4147-A177-3AD203B41FA5}">
                      <a16:colId xmlns:a16="http://schemas.microsoft.com/office/drawing/2014/main" xmlns="" val="3808794518"/>
                    </a:ext>
                  </a:extLst>
                </a:gridCol>
                <a:gridCol w="710213">
                  <a:extLst>
                    <a:ext uri="{9D8B030D-6E8A-4147-A177-3AD203B41FA5}">
                      <a16:colId xmlns:a16="http://schemas.microsoft.com/office/drawing/2014/main" xmlns="" val="1357353812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racteristi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w PGR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gh PGR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isti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o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050165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6045264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isq.tes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7162461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 (18.1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 (20.3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4620462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 (30.5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 (28.9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5616563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.4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0.8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037026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4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isq.tes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1007890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2 (38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5 (43.4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7373317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 (11.7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 (6.8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6730147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sher.tes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3250969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0 (50.2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5 (49.1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673532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0.4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0.2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881995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, mean ± S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33 ± 6.6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73 ± 6.9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tes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7045706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F073DFFF-955B-4745-AD81-6DEEFD56FC04}"/>
              </a:ext>
            </a:extLst>
          </p:cNvPr>
          <p:cNvSpPr txBox="1"/>
          <p:nvPr/>
        </p:nvSpPr>
        <p:spPr>
          <a:xfrm>
            <a:off x="3596197" y="1895995"/>
            <a:ext cx="43858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able S3. PGR correlation with TNM categories in prostate cancers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xmlns="" id="{8988EC36-D71B-4CC0-B3D9-010EA0BE40D7}"/>
              </a:ext>
            </a:extLst>
          </p:cNvPr>
          <p:cNvCxnSpPr/>
          <p:nvPr/>
        </p:nvCxnSpPr>
        <p:spPr>
          <a:xfrm>
            <a:off x="3075531" y="4685006"/>
            <a:ext cx="54272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xmlns="" id="{7ACD7110-6BAF-4AA1-ABBE-DBF3375EB44E}"/>
              </a:ext>
            </a:extLst>
          </p:cNvPr>
          <p:cNvCxnSpPr/>
          <p:nvPr/>
        </p:nvCxnSpPr>
        <p:spPr>
          <a:xfrm>
            <a:off x="3032621" y="2190750"/>
            <a:ext cx="54272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xmlns="" id="{F564A6BD-A899-4260-883A-BC9D192EB83D}"/>
              </a:ext>
            </a:extLst>
          </p:cNvPr>
          <p:cNvCxnSpPr/>
          <p:nvPr/>
        </p:nvCxnSpPr>
        <p:spPr>
          <a:xfrm>
            <a:off x="3032620" y="2387538"/>
            <a:ext cx="54272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118470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xmlns="" id="{CAEE3A19-B257-4876-A32C-B7FAC20AC8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5239594"/>
              </p:ext>
            </p:extLst>
          </p:nvPr>
        </p:nvGraphicFramePr>
        <p:xfrm>
          <a:off x="2704894" y="1935712"/>
          <a:ext cx="5184560" cy="2476500"/>
        </p:xfrm>
        <a:graphic>
          <a:graphicData uri="http://schemas.openxmlformats.org/drawingml/2006/table">
            <a:tbl>
              <a:tblPr/>
              <a:tblGrid>
                <a:gridCol w="1154098">
                  <a:extLst>
                    <a:ext uri="{9D8B030D-6E8A-4147-A177-3AD203B41FA5}">
                      <a16:colId xmlns:a16="http://schemas.microsoft.com/office/drawing/2014/main" xmlns="" val="3284565697"/>
                    </a:ext>
                  </a:extLst>
                </a:gridCol>
                <a:gridCol w="1047565">
                  <a:extLst>
                    <a:ext uri="{9D8B030D-6E8A-4147-A177-3AD203B41FA5}">
                      <a16:colId xmlns:a16="http://schemas.microsoft.com/office/drawing/2014/main" xmlns="" val="122458958"/>
                    </a:ext>
                  </a:extLst>
                </a:gridCol>
                <a:gridCol w="1091953">
                  <a:extLst>
                    <a:ext uri="{9D8B030D-6E8A-4147-A177-3AD203B41FA5}">
                      <a16:colId xmlns:a16="http://schemas.microsoft.com/office/drawing/2014/main" xmlns="" val="1440939970"/>
                    </a:ext>
                  </a:extLst>
                </a:gridCol>
                <a:gridCol w="603682">
                  <a:extLst>
                    <a:ext uri="{9D8B030D-6E8A-4147-A177-3AD203B41FA5}">
                      <a16:colId xmlns:a16="http://schemas.microsoft.com/office/drawing/2014/main" xmlns="" val="3684061293"/>
                    </a:ext>
                  </a:extLst>
                </a:gridCol>
                <a:gridCol w="594804">
                  <a:extLst>
                    <a:ext uri="{9D8B030D-6E8A-4147-A177-3AD203B41FA5}">
                      <a16:colId xmlns:a16="http://schemas.microsoft.com/office/drawing/2014/main" xmlns="" val="4141327101"/>
                    </a:ext>
                  </a:extLst>
                </a:gridCol>
                <a:gridCol w="692458">
                  <a:extLst>
                    <a:ext uri="{9D8B030D-6E8A-4147-A177-3AD203B41FA5}">
                      <a16:colId xmlns:a16="http://schemas.microsoft.com/office/drawing/2014/main" xmlns="" val="1042502592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racteristi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w PGRMC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gh PGRMC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isti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o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046967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5318487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0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isq.tes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9926613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 (16.7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 (21.7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0792448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2 (32.9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 (26.4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479594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0.6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 (1.6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4338087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isq.tes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9728649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7 (39.2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0 (42.3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1420910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 (10.1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 (8.5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9968568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stage, 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sher.tes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7380581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4 (48.9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1 (50.4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5151681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0.4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0.2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1961632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, median (IQR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 (57, 66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 (55, 66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172.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lcoxo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26931571"/>
                  </a:ext>
                </a:extLst>
              </a:tr>
            </a:tbl>
          </a:graphicData>
        </a:graphic>
      </p:graphicFrame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xmlns="" id="{AF00400B-FFF9-4AEF-8B9B-7641950EFD70}"/>
              </a:ext>
            </a:extLst>
          </p:cNvPr>
          <p:cNvCxnSpPr/>
          <p:nvPr/>
        </p:nvCxnSpPr>
        <p:spPr>
          <a:xfrm>
            <a:off x="2630914" y="4439860"/>
            <a:ext cx="54272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xmlns="" id="{317597B2-800C-46B3-86B7-98355109F2AD}"/>
              </a:ext>
            </a:extLst>
          </p:cNvPr>
          <p:cNvCxnSpPr/>
          <p:nvPr/>
        </p:nvCxnSpPr>
        <p:spPr>
          <a:xfrm>
            <a:off x="2630914" y="2146017"/>
            <a:ext cx="54272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xmlns="" id="{F4F18B4F-2279-417A-B19E-97C071869A82}"/>
              </a:ext>
            </a:extLst>
          </p:cNvPr>
          <p:cNvCxnSpPr/>
          <p:nvPr/>
        </p:nvCxnSpPr>
        <p:spPr>
          <a:xfrm>
            <a:off x="2630914" y="1935712"/>
            <a:ext cx="54272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811EED43-370A-419C-ACDB-4B262E7F38ED}"/>
              </a:ext>
            </a:extLst>
          </p:cNvPr>
          <p:cNvSpPr txBox="1"/>
          <p:nvPr/>
        </p:nvSpPr>
        <p:spPr>
          <a:xfrm>
            <a:off x="3151580" y="1625367"/>
            <a:ext cx="4680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able S4. PGRMC1 correlation with TNM categories in prostate cancers</a:t>
            </a:r>
          </a:p>
        </p:txBody>
      </p:sp>
    </p:spTree>
    <p:extLst>
      <p:ext uri="{BB962C8B-B14F-4D97-AF65-F5344CB8AC3E}">
        <p14:creationId xmlns:p14="http://schemas.microsoft.com/office/powerpoint/2010/main" val="843442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84</TotalTime>
  <Words>504</Words>
  <Application>Microsoft Office PowerPoint</Application>
  <PresentationFormat>Widescreen</PresentationFormat>
  <Paragraphs>19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yi Li</dc:creator>
  <cp:lastModifiedBy>MDPI</cp:lastModifiedBy>
  <cp:revision>213</cp:revision>
  <dcterms:created xsi:type="dcterms:W3CDTF">2021-07-25T14:08:21Z</dcterms:created>
  <dcterms:modified xsi:type="dcterms:W3CDTF">2021-09-18T10:12:24Z</dcterms:modified>
</cp:coreProperties>
</file>